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93" d="100"/>
          <a:sy n="93" d="100"/>
        </p:scale>
        <p:origin x="90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C90D29F-E975-40BA-A665-FD353FDC9AA6}" type="datetimeFigureOut">
              <a:rPr lang="en-US" smtClean="0"/>
              <a:t>3/14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4B12E34-6194-4270-AA5B-76CBB05BDB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111238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algn="just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solidFill>
                  <a:srgbClr val="333132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</a:t>
            </a:r>
            <a:r>
              <a:rPr lang="en-US" sz="1800" b="1">
                <a:solidFill>
                  <a:srgbClr val="333132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9</a:t>
            </a:r>
            <a:r>
              <a:rPr lang="en-US" sz="1800" b="1" dirty="0">
                <a:solidFill>
                  <a:srgbClr val="333132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: Additional relevant IPA-derived networks from transcriptomics, astrocytes treated with GBM F3-8 EVs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 algn="just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solidFill>
                  <a:srgbClr val="333132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A) Network 4: “Cell Morphology, Hematological System Development and Function, 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 algn="just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solidFill>
                  <a:srgbClr val="333132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nfectious Diseases”; Score = 32; Focus Molecules = 22. (B) Network 5: “Endocrine System Disorders, Gastrointestinal Disease, Immunological Disease”; Score = 26; Focus Molecules = 19. 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core and Focus Molecule definitions are the same as in Figure 2.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4B12E34-6194-4270-AA5B-76CBB05BDB4E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148525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330E873-0DE1-4CE9-C0E8-4E2EB6A2E89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BB5F54D-2A7D-27BC-DD91-C3F5101DC40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DCE2F3C-1859-9ADE-BF50-C9CFCADECC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B4B03C-4412-4A2D-B321-C004B710FE1B}" type="datetimeFigureOut">
              <a:rPr lang="en-US" smtClean="0"/>
              <a:t>3/14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7389E7F-FEDD-B42D-7A8C-7B3CE304C6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C79C68E-FC3C-A6FF-6181-F6F0A1982D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EA08F-B6F3-4B2E-A585-E72930A901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93432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8A89AA-7BAE-9734-646B-954A38BF8D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ECF8861-033E-27D1-B529-E2FF1C50899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7275979-EDC6-8D1D-A662-4A7A06CE10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B4B03C-4412-4A2D-B321-C004B710FE1B}" type="datetimeFigureOut">
              <a:rPr lang="en-US" smtClean="0"/>
              <a:t>3/14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424A0D3-FB5F-C7A7-1FC5-1E910FEEE1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AA69011-4C5F-9185-9941-D7C98FD360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EA08F-B6F3-4B2E-A585-E72930A901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1356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8D1B549-B07A-CE2B-CBA6-DDA48F47AB1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84AD075-BA39-F644-1F32-4654492D727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BE542D8-8CDA-9D0D-E918-6777027931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B4B03C-4412-4A2D-B321-C004B710FE1B}" type="datetimeFigureOut">
              <a:rPr lang="en-US" smtClean="0"/>
              <a:t>3/14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89F333F-9563-FFCD-28B7-85E35F8CA0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C52FDBB-0D73-B98D-69D9-0B0C55143D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EA08F-B6F3-4B2E-A585-E72930A901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90656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0BBB63-BD3F-59E5-F0A2-5C7ACB4F253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E325418-BD71-5075-3422-90D2861B036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8A57D03-7E75-E59E-33C1-BD5A79892A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B4B03C-4412-4A2D-B321-C004B710FE1B}" type="datetimeFigureOut">
              <a:rPr lang="en-US" smtClean="0"/>
              <a:t>3/14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60E7B5F-194C-5914-62BD-9157F2099C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64861EA-35CF-5F6A-EEDD-95EDC61B01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EA08F-B6F3-4B2E-A585-E72930A901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13826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07BEAAE-C58B-3000-5AD7-D9D30446E4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EFEF8DB-3BCF-B040-F02C-E64EFBA6A15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2BD1B64-A606-E9FE-BDBD-DEDFF14B03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B4B03C-4412-4A2D-B321-C004B710FE1B}" type="datetimeFigureOut">
              <a:rPr lang="en-US" smtClean="0"/>
              <a:t>3/14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6A0DB29-331E-0548-D0FC-657DF37BC9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A37CB7B-E56C-903E-CD05-5FF333EBAD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EA08F-B6F3-4B2E-A585-E72930A901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07443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6A18D9-C85A-14B9-1156-CDB86128ADE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84C12BF-FE08-FDC5-6E59-F339A92BB0D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BF432E6-6427-7823-6986-4F5EB87DF55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9291BD6-153F-8D1B-2FDC-92F889982B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B4B03C-4412-4A2D-B321-C004B710FE1B}" type="datetimeFigureOut">
              <a:rPr lang="en-US" smtClean="0"/>
              <a:t>3/14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84D5527-29E4-B0D0-9E88-A63007CC7C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5F8EF9A-584B-2CDC-94E9-A1655D6116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EA08F-B6F3-4B2E-A585-E72930A901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50268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D32E93-A7A8-90CC-00AF-83E0F27BA1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8A19447-483D-0A1A-7759-54A408ED407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3C84B4B-7493-E2A4-17F5-FF2FA1D261E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B549E11-3DEF-3494-48FF-B66E4F73D9C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0BE599B-6BDA-879C-9D8C-1F2A776A9A2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81D67C2-31A7-423F-E610-C4B0B0EAFF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B4B03C-4412-4A2D-B321-C004B710FE1B}" type="datetimeFigureOut">
              <a:rPr lang="en-US" smtClean="0"/>
              <a:t>3/14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4204ED5-0269-F27B-9663-0FBB87A4C1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7EF0568-781A-CE38-6DDA-AA85DBFBFD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EA08F-B6F3-4B2E-A585-E72930A901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31267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48D889A-88ED-CD81-571C-BD9D60661EC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40C5DD8-0F29-D5B9-DDAD-0265B0E53B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B4B03C-4412-4A2D-B321-C004B710FE1B}" type="datetimeFigureOut">
              <a:rPr lang="en-US" smtClean="0"/>
              <a:t>3/14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417BAAF-0D7C-C036-8068-E7D76D22C8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B574E66-1237-102C-BD03-4136903200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EA08F-B6F3-4B2E-A585-E72930A901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04937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8A3F1D0-3671-FC0D-EE81-E3391B4DFA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B4B03C-4412-4A2D-B321-C004B710FE1B}" type="datetimeFigureOut">
              <a:rPr lang="en-US" smtClean="0"/>
              <a:t>3/14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E243A09-28E9-3E2F-1703-2BD2392BC7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9F45EF0-44B5-3283-415A-78926D06C6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EA08F-B6F3-4B2E-A585-E72930A901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91002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8CD928-C1BD-636C-13D7-42BE3FDA25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1337C3B-1D85-453D-5704-CCA8BB2457B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44E33DE-F423-C990-ABF3-377CE5FE205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AEF3AB7-D0BF-05AD-A76D-9A3FD990D6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B4B03C-4412-4A2D-B321-C004B710FE1B}" type="datetimeFigureOut">
              <a:rPr lang="en-US" smtClean="0"/>
              <a:t>3/14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DA6AC5D-BF56-5736-3637-A627AC0FBE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E29DBB8-5D09-59A6-5B68-457709A155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EA08F-B6F3-4B2E-A585-E72930A901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02905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D5C44C-0495-AA0A-139D-6AD709107A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6390BC4-1BA3-590E-2600-C48161518F7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0DB8057-6B67-6A13-4C81-C1F64AE6285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FDF512A-6BD5-4B1A-1905-789F485A8D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B4B03C-4412-4A2D-B321-C004B710FE1B}" type="datetimeFigureOut">
              <a:rPr lang="en-US" smtClean="0"/>
              <a:t>3/14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4C6715D-B596-2984-F658-9B70662453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41D4B30-82EC-62B6-318B-E295812704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AEA08F-B6F3-4B2E-A585-E72930A901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30071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B0DDD00-F996-5B93-C961-C826A6793A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5C7A99E-FB62-4A48-5DE1-8E5D6C07419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8FEFF00-15AA-7551-2723-F17FB9A264F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B4B03C-4412-4A2D-B321-C004B710FE1B}" type="datetimeFigureOut">
              <a:rPr lang="en-US" smtClean="0"/>
              <a:t>3/14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6266DD2-29EF-BC29-719D-A4AF393C83F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44A59E2-8B01-FDEA-61CE-2B6EE1603D0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AEA08F-B6F3-4B2E-A585-E72930A901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41938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AB6ABF69-42BD-01B3-745B-ABFDF55A46DC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76" t="3398" r="4001" b="4314"/>
          <a:stretch/>
        </p:blipFill>
        <p:spPr>
          <a:xfrm>
            <a:off x="537882" y="484754"/>
            <a:ext cx="5749070" cy="5462777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ED002631-D221-E46A-F556-F0D5B64F408E}"/>
              </a:ext>
            </a:extLst>
          </p:cNvPr>
          <p:cNvSpPr txBox="1"/>
          <p:nvPr/>
        </p:nvSpPr>
        <p:spPr>
          <a:xfrm>
            <a:off x="770964" y="6139293"/>
            <a:ext cx="445846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Network 4</a:t>
            </a:r>
          </a:p>
          <a:p>
            <a:r>
              <a:rPr lang="en-US" sz="1200" dirty="0"/>
              <a:t>Cell Morphology, Hematological System Development and Function, </a:t>
            </a:r>
          </a:p>
          <a:p>
            <a:r>
              <a:rPr lang="en-US" sz="1200" dirty="0"/>
              <a:t>Infectious Diseases, Score = 32; Focus Molecules = 22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745AAB4F-5129-83EB-B467-9900A31E0B60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30" t="2875" r="4271" b="4445"/>
          <a:stretch/>
        </p:blipFill>
        <p:spPr>
          <a:xfrm>
            <a:off x="6917748" y="72376"/>
            <a:ext cx="4814048" cy="5894922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B779BC2E-8F19-5703-B9B2-32E4BAF728DE}"/>
              </a:ext>
            </a:extLst>
          </p:cNvPr>
          <p:cNvSpPr txBox="1"/>
          <p:nvPr/>
        </p:nvSpPr>
        <p:spPr>
          <a:xfrm>
            <a:off x="6490447" y="6139292"/>
            <a:ext cx="376545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Network 5</a:t>
            </a:r>
          </a:p>
          <a:p>
            <a:r>
              <a:rPr lang="en-US" sz="1200" dirty="0"/>
              <a:t>Endocrine System Disorders, Gastrointestinal Disease, </a:t>
            </a:r>
          </a:p>
          <a:p>
            <a:r>
              <a:rPr lang="en-US" sz="1200" dirty="0"/>
              <a:t>Immunological Disease, Score = 26; Focus Molecules = 19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9788EF69-E6B0-F050-60C1-079CABDDA5D9}"/>
              </a:ext>
            </a:extLst>
          </p:cNvPr>
          <p:cNvSpPr txBox="1"/>
          <p:nvPr/>
        </p:nvSpPr>
        <p:spPr>
          <a:xfrm>
            <a:off x="430306" y="690282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D7C05A0B-E653-0EFB-B099-C35B8F71A76B}"/>
              </a:ext>
            </a:extLst>
          </p:cNvPr>
          <p:cNvSpPr txBox="1"/>
          <p:nvPr/>
        </p:nvSpPr>
        <p:spPr>
          <a:xfrm>
            <a:off x="6423563" y="690282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C3D4EDD-9267-3CC4-1C00-9926504DBF1D}"/>
              </a:ext>
            </a:extLst>
          </p:cNvPr>
          <p:cNvSpPr txBox="1"/>
          <p:nvPr/>
        </p:nvSpPr>
        <p:spPr>
          <a:xfrm>
            <a:off x="0" y="70843"/>
            <a:ext cx="170110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 S9</a:t>
            </a:r>
          </a:p>
        </p:txBody>
      </p:sp>
    </p:spTree>
    <p:extLst>
      <p:ext uri="{BB962C8B-B14F-4D97-AF65-F5344CB8AC3E}">
        <p14:creationId xmlns:p14="http://schemas.microsoft.com/office/powerpoint/2010/main" val="33926479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132</Words>
  <Application>Microsoft Office PowerPoint</Application>
  <PresentationFormat>Widescreen</PresentationFormat>
  <Paragraphs>1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hael Graner</dc:creator>
  <cp:lastModifiedBy>Michael Graner</cp:lastModifiedBy>
  <cp:revision>3</cp:revision>
  <dcterms:created xsi:type="dcterms:W3CDTF">2023-02-27T03:42:24Z</dcterms:created>
  <dcterms:modified xsi:type="dcterms:W3CDTF">2023-03-14T21:46:06Z</dcterms:modified>
</cp:coreProperties>
</file>